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84" autoAdjust="0"/>
    <p:restoredTop sz="94660"/>
  </p:normalViewPr>
  <p:slideViewPr>
    <p:cSldViewPr snapToGrid="0">
      <p:cViewPr varScale="1">
        <p:scale>
          <a:sx n="68" d="100"/>
          <a:sy n="68" d="100"/>
        </p:scale>
        <p:origin x="1152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cello Otake Sato" userId="f860b592-28d6-473e-9f4b-e165cc1e8e58" providerId="ADAL" clId="{97108E93-FB72-41E5-BE11-E59908C87135}"/>
    <pc:docChg chg="modSld">
      <pc:chgData name="Marcello Otake Sato" userId="f860b592-28d6-473e-9f4b-e165cc1e8e58" providerId="ADAL" clId="{97108E93-FB72-41E5-BE11-E59908C87135}" dt="2025-07-29T07:24:04.752" v="3" actId="6549"/>
      <pc:docMkLst>
        <pc:docMk/>
      </pc:docMkLst>
      <pc:sldChg chg="modSp mod">
        <pc:chgData name="Marcello Otake Sato" userId="f860b592-28d6-473e-9f4b-e165cc1e8e58" providerId="ADAL" clId="{97108E93-FB72-41E5-BE11-E59908C87135}" dt="2025-07-29T07:24:04.752" v="3" actId="6549"/>
        <pc:sldMkLst>
          <pc:docMk/>
          <pc:sldMk cId="1407184433" sldId="256"/>
        </pc:sldMkLst>
        <pc:spChg chg="mod">
          <ac:chgData name="Marcello Otake Sato" userId="f860b592-28d6-473e-9f4b-e165cc1e8e58" providerId="ADAL" clId="{97108E93-FB72-41E5-BE11-E59908C87135}" dt="2025-07-29T07:24:04.752" v="3" actId="6549"/>
          <ac:spMkLst>
            <pc:docMk/>
            <pc:sldMk cId="1407184433" sldId="256"/>
            <ac:spMk id="5" creationId="{46F0CFD1-C9C5-4D6A-C684-1B7A90E73D9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851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880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658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254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857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669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991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678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289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555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006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DDAFD60-5ABD-472F-B297-69678ABB9F85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C3D9AA4-7E49-44E8-A616-3DC385F2F7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55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6F0CFD1-C9C5-4D6A-C684-1B7A90E73D99}"/>
              </a:ext>
            </a:extLst>
          </p:cNvPr>
          <p:cNvSpPr txBox="1"/>
          <p:nvPr/>
        </p:nvSpPr>
        <p:spPr>
          <a:xfrm>
            <a:off x="967174" y="4984918"/>
            <a:ext cx="4896216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</a:rPr>
              <a:t>Supplemental Figure 1. Comparison between the water proximity of the soil sampling and overall eDNA positivity in Phase 1 using the Wilcoxon two-sample/Mann-Whitney U test. No statistically significant difference was observed in the </a:t>
            </a:r>
            <a:r>
              <a:rPr lang="en-US" sz="1200" i="1" dirty="0">
                <a:latin typeface="Arial" panose="020B0604020202020204" pitchFamily="34" charset="0"/>
              </a:rPr>
              <a:t>O. h. </a:t>
            </a:r>
            <a:r>
              <a:rPr lang="en-US" sz="1200" i="1" dirty="0" err="1">
                <a:latin typeface="Arial" panose="020B0604020202020204" pitchFamily="34" charset="0"/>
              </a:rPr>
              <a:t>quadrasi</a:t>
            </a:r>
            <a:r>
              <a:rPr lang="en-US" sz="1200" dirty="0">
                <a:latin typeface="Arial" panose="020B0604020202020204" pitchFamily="34" charset="0"/>
              </a:rPr>
              <a:t> and </a:t>
            </a:r>
            <a:r>
              <a:rPr lang="en-US" sz="1200" i="1" dirty="0">
                <a:latin typeface="Arial" panose="020B0604020202020204" pitchFamily="34" charset="0"/>
              </a:rPr>
              <a:t>S. japonicum multiplex</a:t>
            </a:r>
            <a:r>
              <a:rPr lang="en-US" sz="1200" dirty="0">
                <a:latin typeface="Arial" panose="020B0604020202020204" pitchFamily="34" charset="0"/>
              </a:rPr>
              <a:t> qPCR results and the sampling distance from the riverbank (p</a:t>
            </a:r>
            <a:r>
              <a:rPr lang="en-US" sz="1200">
                <a:latin typeface="Arial" panose="020B0604020202020204" pitchFamily="34" charset="0"/>
              </a:rPr>
              <a:t>&gt;0.05</a:t>
            </a:r>
            <a:r>
              <a:rPr lang="en-US" sz="1200" dirty="0">
                <a:latin typeface="Arial" panose="020B0604020202020204" pitchFamily="34" charset="0"/>
              </a:rPr>
              <a:t>), indicating equal likelihood of eDNA detection regardless of water proximity </a:t>
            </a:r>
            <a:r>
              <a:rPr lang="en-US" sz="1200">
                <a:latin typeface="Arial" panose="020B0604020202020204" pitchFamily="34" charset="0"/>
              </a:rPr>
              <a:t>within 2.5 </a:t>
            </a:r>
            <a:r>
              <a:rPr lang="en-US" sz="1200" dirty="0">
                <a:latin typeface="Arial" panose="020B0604020202020204" pitchFamily="34" charset="0"/>
              </a:rPr>
              <a:t>meters from the watercourse bank.</a:t>
            </a:r>
            <a:endParaRPr lang="en-US" sz="1200" dirty="0"/>
          </a:p>
        </p:txBody>
      </p:sp>
      <p:pic>
        <p:nvPicPr>
          <p:cNvPr id="7" name="Picture 6" descr="A diagram of a number of lines&#10;&#10;AI-generated content may be incorrect.">
            <a:extLst>
              <a:ext uri="{FF2B5EF4-FFF2-40B4-BE49-F238E27FC236}">
                <a16:creationId xmlns:a16="http://schemas.microsoft.com/office/drawing/2014/main" id="{5147FD58-8FC8-1580-C519-66AB6E4ADF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4182" y="1314787"/>
            <a:ext cx="4659752" cy="32572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7184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7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cello Otake Sato</dc:creator>
  <cp:lastModifiedBy>Marcello Otake Sato</cp:lastModifiedBy>
  <cp:revision>1</cp:revision>
  <dcterms:created xsi:type="dcterms:W3CDTF">2025-06-05T01:39:44Z</dcterms:created>
  <dcterms:modified xsi:type="dcterms:W3CDTF">2025-07-29T07:24:06Z</dcterms:modified>
</cp:coreProperties>
</file>